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3" r:id="rId4"/>
    <p:sldId id="262" r:id="rId5"/>
    <p:sldId id="261" r:id="rId6"/>
    <p:sldId id="259" r:id="rId7"/>
    <p:sldId id="264" r:id="rId8"/>
    <p:sldId id="269" r:id="rId9"/>
    <p:sldId id="267" r:id="rId10"/>
    <p:sldId id="268" r:id="rId11"/>
    <p:sldId id="266" r:id="rId12"/>
    <p:sldId id="272" r:id="rId13"/>
    <p:sldId id="265" r:id="rId14"/>
    <p:sldId id="271" r:id="rId15"/>
    <p:sldId id="270" r:id="rId16"/>
    <p:sldId id="273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6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062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18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454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786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916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798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874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94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075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56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B75FE-3FBA-4EBA-8857-54D33EDE6739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F4D99B-108F-4B73-AEB3-36AADDD8A8F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658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g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gi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gi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g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00075" y="123825"/>
            <a:ext cx="421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1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38250"/>
            <a:ext cx="4762500" cy="438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4308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6467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3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</a:t>
            </a:r>
            <a:r>
              <a:rPr lang="de-CH" sz="2400" dirty="0" err="1" smtClean="0"/>
              <a:t>location</a:t>
            </a:r>
            <a:r>
              <a:rPr lang="de-CH" sz="2400" dirty="0" smtClean="0"/>
              <a:t> </a:t>
            </a:r>
            <a:r>
              <a:rPr lang="de-CH" sz="2400" dirty="0" smtClean="0"/>
              <a:t>D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90637"/>
            <a:ext cx="4762500" cy="4276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283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791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3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Location C</a:t>
            </a:r>
            <a:endParaRPr lang="en-US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66825"/>
            <a:ext cx="4762500" cy="4324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7724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8864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3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Location </a:t>
            </a:r>
            <a:r>
              <a:rPr lang="de-CH" sz="2400" dirty="0" smtClean="0"/>
              <a:t>D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71587"/>
            <a:ext cx="4762500" cy="4314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13075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9626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4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</a:t>
            </a:r>
            <a:r>
              <a:rPr lang="de-CH" sz="2400" dirty="0" err="1" smtClean="0"/>
              <a:t>Outlier</a:t>
            </a:r>
            <a:r>
              <a:rPr lang="de-CH" sz="2400" dirty="0" smtClean="0"/>
              <a:t> </a:t>
            </a:r>
            <a:r>
              <a:rPr lang="de-CH" sz="2400" dirty="0" err="1" smtClean="0"/>
              <a:t>A1</a:t>
            </a:r>
            <a:endParaRPr lang="en-US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81112"/>
            <a:ext cx="4762500" cy="4295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0770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7054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4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</a:t>
            </a:r>
            <a:r>
              <a:rPr lang="de-CH" sz="2400" dirty="0" err="1" smtClean="0"/>
              <a:t>Outlier</a:t>
            </a:r>
            <a:r>
              <a:rPr lang="de-CH" sz="2400" dirty="0" smtClean="0"/>
              <a:t> </a:t>
            </a:r>
            <a:r>
              <a:rPr lang="de-CH" sz="2400" dirty="0" err="1" smtClean="0"/>
              <a:t>A1</a:t>
            </a:r>
            <a:endParaRPr lang="en-US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62062"/>
            <a:ext cx="4762500" cy="4333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22862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524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4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</a:t>
            </a:r>
            <a:r>
              <a:rPr lang="de-CH" sz="2400" dirty="0" err="1" smtClean="0"/>
              <a:t>Outlier</a:t>
            </a:r>
            <a:r>
              <a:rPr lang="de-CH" sz="2400" dirty="0" smtClean="0"/>
              <a:t> </a:t>
            </a:r>
            <a:r>
              <a:rPr lang="de-CH" sz="2400" dirty="0" err="1" smtClean="0"/>
              <a:t>A2</a:t>
            </a:r>
            <a:endParaRPr lang="en-US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23962"/>
            <a:ext cx="4762500" cy="4410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362073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8102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4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</a:t>
            </a:r>
            <a:r>
              <a:rPr lang="de-CH" sz="2400" dirty="0" err="1" smtClean="0"/>
              <a:t>Outlier</a:t>
            </a:r>
            <a:r>
              <a:rPr lang="de-CH" sz="2400" dirty="0" smtClean="0"/>
              <a:t> </a:t>
            </a:r>
            <a:r>
              <a:rPr lang="de-CH" sz="2400" dirty="0" err="1" smtClean="0"/>
              <a:t>A2</a:t>
            </a:r>
            <a:endParaRPr lang="en-US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57300"/>
            <a:ext cx="4762500" cy="434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1674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00075" y="123825"/>
            <a:ext cx="421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1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Frontal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9125" y="1252537"/>
            <a:ext cx="3333750" cy="4352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4641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00075" y="123825"/>
            <a:ext cx="421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1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47775"/>
            <a:ext cx="4762500" cy="4362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71871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00075" y="123825"/>
            <a:ext cx="4876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1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Frontal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7700" y="1285875"/>
            <a:ext cx="3276600" cy="4286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1438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600075" y="123825"/>
            <a:ext cx="421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2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Frontal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2937" y="1219200"/>
            <a:ext cx="3286125" cy="441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4763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309687"/>
            <a:ext cx="4762500" cy="4238625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600075" y="123825"/>
            <a:ext cx="42195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2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2175268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895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2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</a:t>
            </a:r>
            <a:endParaRPr lang="en-US" sz="2400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57300"/>
            <a:ext cx="4762500" cy="4343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65328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42195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2, </a:t>
            </a:r>
            <a:r>
              <a:rPr lang="de-CH" sz="2400" dirty="0" err="1" smtClean="0"/>
              <a:t>with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Frontal</a:t>
            </a:r>
            <a:endParaRPr lang="en-US" sz="24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8650" y="1123950"/>
            <a:ext cx="3314700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67631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00075" y="123825"/>
            <a:ext cx="55911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dirty="0" smtClean="0"/>
              <a:t>Experiment 3, </a:t>
            </a:r>
            <a:r>
              <a:rPr lang="de-CH" sz="2400" dirty="0" err="1" smtClean="0"/>
              <a:t>No</a:t>
            </a:r>
            <a:r>
              <a:rPr lang="de-CH" sz="2400" dirty="0" smtClean="0"/>
              <a:t> </a:t>
            </a:r>
            <a:r>
              <a:rPr lang="de-CH" sz="2400" dirty="0" err="1" smtClean="0"/>
              <a:t>OARs</a:t>
            </a:r>
            <a:r>
              <a:rPr lang="de-CH" sz="2400" dirty="0" smtClean="0"/>
              <a:t>, Axial, Location C</a:t>
            </a:r>
            <a:endParaRPr lang="en-US" sz="24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4750" y="1238250"/>
            <a:ext cx="4762500" cy="438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7124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Breitbild</PresentationFormat>
  <Paragraphs>16</Paragraphs>
  <Slides>1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Insel Grupp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oel, Robert</dc:creator>
  <cp:lastModifiedBy>Poel, Robert</cp:lastModifiedBy>
  <cp:revision>5</cp:revision>
  <dcterms:created xsi:type="dcterms:W3CDTF">2022-03-01T15:24:36Z</dcterms:created>
  <dcterms:modified xsi:type="dcterms:W3CDTF">2022-06-23T08:19:36Z</dcterms:modified>
</cp:coreProperties>
</file>